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9" autoAdjust="0"/>
  </p:normalViewPr>
  <p:slideViewPr>
    <p:cSldViewPr>
      <p:cViewPr>
        <p:scale>
          <a:sx n="112" d="100"/>
          <a:sy n="112" d="100"/>
        </p:scale>
        <p:origin x="-180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358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52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10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81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17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1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22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220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3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694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885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CD15-C9D0-47C0-B429-15B0D256D383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134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1933485"/>
              </p:ext>
            </p:extLst>
          </p:nvPr>
        </p:nvGraphicFramePr>
        <p:xfrm>
          <a:off x="481166" y="1530923"/>
          <a:ext cx="5426138" cy="102485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3476"/>
                <a:gridCol w="2434856"/>
                <a:gridCol w="542260"/>
                <a:gridCol w="839972"/>
                <a:gridCol w="835574"/>
              </a:tblGrid>
              <a:tr h="180104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ue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</a:tr>
              <a:tr h="174028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oside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</a:tr>
              <a:tr h="174028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nase activity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</a:tr>
              <a:tr h="174028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9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5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</a:tr>
              <a:tr h="174028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ction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8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01" marR="8701" marT="8701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96102" y="1283586"/>
            <a:ext cx="3448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genes in KMT2A KD only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534068"/>
              </p:ext>
            </p:extLst>
          </p:nvPr>
        </p:nvGraphicFramePr>
        <p:xfrm>
          <a:off x="481166" y="2901820"/>
          <a:ext cx="5426138" cy="11661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7867"/>
                <a:gridCol w="2430465"/>
                <a:gridCol w="531628"/>
                <a:gridCol w="850604"/>
                <a:gridCol w="835574"/>
              </a:tblGrid>
              <a:tr h="164568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ue</a:t>
                      </a:r>
                      <a:endParaRPr lang="en-GB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  <a:tr h="15328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R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kyrin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  <a:tr h="15328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ction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8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  <a:tr h="15328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keleta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binding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6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  <a:tr h="15328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hesion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  <a:tr h="15328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jection organization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x10</a:t>
                      </a:r>
                      <a:r>
                        <a:rPr lang="en-GB" sz="105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5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4" marR="7664" marT="7664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6102" y="2658146"/>
            <a:ext cx="33361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genes in MSK1 KD only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3135710"/>
              </p:ext>
            </p:extLst>
          </p:nvPr>
        </p:nvGraphicFramePr>
        <p:xfrm>
          <a:off x="481166" y="4375784"/>
          <a:ext cx="5426138" cy="64800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3476"/>
                <a:gridCol w="2434772"/>
                <a:gridCol w="531712"/>
                <a:gridCol w="850604"/>
                <a:gridCol w="835574"/>
              </a:tblGrid>
              <a:tr h="11940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ue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</a:tr>
              <a:tr h="16741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ty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d biosynthetic proces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</a:tr>
              <a:tr h="16741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pid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ynthetic proces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71" marR="8371" marT="8371" marB="0" anchor="b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96102" y="4139952"/>
            <a:ext cx="40121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p-regulated genes in KMT2A AND MSK1 K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1603402"/>
              </p:ext>
            </p:extLst>
          </p:nvPr>
        </p:nvGraphicFramePr>
        <p:xfrm>
          <a:off x="481166" y="5370180"/>
          <a:ext cx="5426138" cy="16500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3476"/>
                <a:gridCol w="2432213"/>
                <a:gridCol w="536201"/>
                <a:gridCol w="859307"/>
                <a:gridCol w="824941"/>
              </a:tblGrid>
              <a:tr h="21432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ue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6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4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3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e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omeric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3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7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0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tubule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skelet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7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2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 DNA damage stimulu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7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Pase</a:t>
                      </a: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or activity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  <a:tr h="16711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inc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n bind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1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356" marR="8356" marT="8356" marB="0" anchor="b"/>
                </a:tc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2976339"/>
              </p:ext>
            </p:extLst>
          </p:nvPr>
        </p:nvGraphicFramePr>
        <p:xfrm>
          <a:off x="481166" y="7391880"/>
          <a:ext cx="5426138" cy="1435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5535"/>
                <a:gridCol w="2432797"/>
                <a:gridCol w="531628"/>
                <a:gridCol w="848452"/>
                <a:gridCol w="837726"/>
              </a:tblGrid>
              <a:tr h="15123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alue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Enrichment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PI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oprotei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0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8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C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cellular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idation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uc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3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ity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gment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ifferenti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2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hydrate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  <a:tr h="159626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B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xylic </a:t>
                      </a:r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id catabolic proces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2x10</a:t>
                      </a:r>
                      <a:r>
                        <a:rPr lang="en-GB" sz="1000" u="none" strike="noStrike" baseline="300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4</a:t>
                      </a:r>
                      <a:endParaRPr lang="en-GB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81" marR="7981" marT="7981" marB="0" anchor="b"/>
                </a:tc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20688" y="251520"/>
            <a:ext cx="5693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Additional </a:t>
            </a:r>
            <a:r>
              <a:rPr lang="en-GB" b="1" smtClean="0"/>
              <a:t>File </a:t>
            </a:r>
            <a:r>
              <a:rPr lang="en-GB" b="1" smtClean="0"/>
              <a:t>4</a:t>
            </a:r>
            <a:endParaRPr lang="en-GB" b="1" dirty="0" smtClean="0"/>
          </a:p>
        </p:txBody>
      </p:sp>
      <p:sp>
        <p:nvSpPr>
          <p:cNvPr id="8" name="TextBox 7"/>
          <p:cNvSpPr txBox="1"/>
          <p:nvPr/>
        </p:nvSpPr>
        <p:spPr>
          <a:xfrm>
            <a:off x="396102" y="5128319"/>
            <a:ext cx="3615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wn-regulated genes in MSK1 KD Only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96102" y="7164288"/>
            <a:ext cx="42605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wn-regulated genes in KMT2A AND MSK1 K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8915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0</TotalTime>
  <Words>234</Words>
  <Application>Microsoft Office PowerPoint</Application>
  <PresentationFormat>On-screen Show (4:3)</PresentationFormat>
  <Paragraphs>1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aike Wiersma</dc:creator>
  <cp:lastModifiedBy>John Halsall</cp:lastModifiedBy>
  <cp:revision>27</cp:revision>
  <cp:lastPrinted>2016-01-20T13:43:26Z</cp:lastPrinted>
  <dcterms:created xsi:type="dcterms:W3CDTF">2015-09-25T13:30:58Z</dcterms:created>
  <dcterms:modified xsi:type="dcterms:W3CDTF">2016-10-28T11:09:29Z</dcterms:modified>
</cp:coreProperties>
</file>